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3" r:id="rId2"/>
  </p:sldIdLst>
  <p:sldSz cx="9144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969"/>
    <p:restoredTop sz="94648"/>
  </p:normalViewPr>
  <p:slideViewPr>
    <p:cSldViewPr snapToGrid="0">
      <p:cViewPr varScale="1">
        <p:scale>
          <a:sx n="53" d="100"/>
          <a:sy n="53" d="100"/>
        </p:scale>
        <p:origin x="34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76CC82-E787-D040-9406-E6C8F2F29A69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E58DD9-2B26-3342-8F72-4A3BFDD476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05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1" name="Google Shape;581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82" name="Google Shape;582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9514568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56703"/>
            <a:ext cx="7772400" cy="50134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563446"/>
            <a:ext cx="6858000" cy="347671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66678"/>
            <a:ext cx="1971675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66678"/>
            <a:ext cx="5800725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9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276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590057"/>
            <a:ext cx="7886700" cy="599008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636813"/>
            <a:ext cx="7886700" cy="31500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5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84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66681"/>
            <a:ext cx="7886700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530053"/>
            <a:ext cx="3868340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260078"/>
            <a:ext cx="3868340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530053"/>
            <a:ext cx="3887391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260078"/>
            <a:ext cx="3887391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32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03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3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073367"/>
            <a:ext cx="4629150" cy="102334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61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073367"/>
            <a:ext cx="4629150" cy="1023348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64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66681"/>
            <a:ext cx="78867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833390"/>
            <a:ext cx="78867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3346867"/>
            <a:ext cx="30861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26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4" name="Google Shape;584;p2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91748" y="1631184"/>
            <a:ext cx="5112267" cy="3021498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8DC4F8A-03C9-8325-7E04-4FCA0DF4F16A}"/>
              </a:ext>
            </a:extLst>
          </p:cNvPr>
          <p:cNvSpPr txBox="1"/>
          <p:nvPr/>
        </p:nvSpPr>
        <p:spPr>
          <a:xfrm>
            <a:off x="601579" y="5442147"/>
            <a:ext cx="7988967" cy="19780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1 NK cells cytotoxicity is not significantly different between estrogen-depleted and estrogen-competent mice.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K cells were sorted based on CD3 (PE) and NK1.1 (APC), and MC-38 were pre-incubated with the Incucyte Cytotox Green Dye (Excitation Max 491 nm, Emission Max 509 nm). The NK cells and MC-38 cells were co-cultured at a ratio of 5:1 for up to 30h. Shown in the figure is quantification of dead (green) MC-38 cells normalized to time 0h (n=3).</a:t>
            </a:r>
          </a:p>
        </p:txBody>
      </p:sp>
    </p:spTree>
    <p:extLst>
      <p:ext uri="{BB962C8B-B14F-4D97-AF65-F5344CB8AC3E}">
        <p14:creationId xmlns:p14="http://schemas.microsoft.com/office/powerpoint/2010/main" val="404155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93</Words>
  <Application>Microsoft Macintosh PowerPoint</Application>
  <PresentationFormat>Custom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e Benslimane (CUSM)</dc:creator>
  <cp:lastModifiedBy>Yasmine Benslimane (CUSM)</cp:lastModifiedBy>
  <cp:revision>7</cp:revision>
  <dcterms:created xsi:type="dcterms:W3CDTF">2024-06-04T23:51:01Z</dcterms:created>
  <dcterms:modified xsi:type="dcterms:W3CDTF">2024-07-10T15:09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7d8d5d-78e2-4a62-9fcd-016eb5e4c57c_Enabled">
    <vt:lpwstr>true</vt:lpwstr>
  </property>
  <property fmtid="{D5CDD505-2E9C-101B-9397-08002B2CF9AE}" pid="3" name="MSIP_Label_6a7d8d5d-78e2-4a62-9fcd-016eb5e4c57c_SetDate">
    <vt:lpwstr>2024-06-04T23:52:34Z</vt:lpwstr>
  </property>
  <property fmtid="{D5CDD505-2E9C-101B-9397-08002B2CF9AE}" pid="4" name="MSIP_Label_6a7d8d5d-78e2-4a62-9fcd-016eb5e4c57c_Method">
    <vt:lpwstr>Standard</vt:lpwstr>
  </property>
  <property fmtid="{D5CDD505-2E9C-101B-9397-08002B2CF9AE}" pid="5" name="MSIP_Label_6a7d8d5d-78e2-4a62-9fcd-016eb5e4c57c_Name">
    <vt:lpwstr>Général</vt:lpwstr>
  </property>
  <property fmtid="{D5CDD505-2E9C-101B-9397-08002B2CF9AE}" pid="6" name="MSIP_Label_6a7d8d5d-78e2-4a62-9fcd-016eb5e4c57c_SiteId">
    <vt:lpwstr>06e1fe28-5f8b-4075-bf6c-ae24be1a7992</vt:lpwstr>
  </property>
  <property fmtid="{D5CDD505-2E9C-101B-9397-08002B2CF9AE}" pid="7" name="MSIP_Label_6a7d8d5d-78e2-4a62-9fcd-016eb5e4c57c_ActionId">
    <vt:lpwstr>7787e28e-b149-4962-94cc-d172c1dcb2b1</vt:lpwstr>
  </property>
  <property fmtid="{D5CDD505-2E9C-101B-9397-08002B2CF9AE}" pid="8" name="MSIP_Label_6a7d8d5d-78e2-4a62-9fcd-016eb5e4c57c_ContentBits">
    <vt:lpwstr>0</vt:lpwstr>
  </property>
</Properties>
</file>